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3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4694"/>
  </p:normalViewPr>
  <p:slideViewPr>
    <p:cSldViewPr snapToGrid="0" snapToObjects="1">
      <p:cViewPr varScale="1">
        <p:scale>
          <a:sx n="96" d="100"/>
          <a:sy n="96" d="100"/>
        </p:scale>
        <p:origin x="33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99E19-0401-B847-99B3-5D6C4012EA79}" type="datetimeFigureOut">
              <a:rPr lang="en-US" smtClean="0"/>
              <a:t>4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E1733-61A6-854D-A974-D957EC93B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824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99E19-0401-B847-99B3-5D6C4012EA79}" type="datetimeFigureOut">
              <a:rPr lang="en-US" smtClean="0"/>
              <a:t>4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E1733-61A6-854D-A974-D957EC93B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523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99E19-0401-B847-99B3-5D6C4012EA79}" type="datetimeFigureOut">
              <a:rPr lang="en-US" smtClean="0"/>
              <a:t>4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E1733-61A6-854D-A974-D957EC93B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5521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99E19-0401-B847-99B3-5D6C4012EA79}" type="datetimeFigureOut">
              <a:rPr lang="en-US" smtClean="0"/>
              <a:t>4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E1733-61A6-854D-A974-D957EC93B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473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99E19-0401-B847-99B3-5D6C4012EA79}" type="datetimeFigureOut">
              <a:rPr lang="en-US" smtClean="0"/>
              <a:t>4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E1733-61A6-854D-A974-D957EC93B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195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99E19-0401-B847-99B3-5D6C4012EA79}" type="datetimeFigureOut">
              <a:rPr lang="en-US" smtClean="0"/>
              <a:t>4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E1733-61A6-854D-A974-D957EC93B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5625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99E19-0401-B847-99B3-5D6C4012EA79}" type="datetimeFigureOut">
              <a:rPr lang="en-US" smtClean="0"/>
              <a:t>4/2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E1733-61A6-854D-A974-D957EC93B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7260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99E19-0401-B847-99B3-5D6C4012EA79}" type="datetimeFigureOut">
              <a:rPr lang="en-US" smtClean="0"/>
              <a:t>4/2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E1733-61A6-854D-A974-D957EC93B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765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99E19-0401-B847-99B3-5D6C4012EA79}" type="datetimeFigureOut">
              <a:rPr lang="en-US" smtClean="0"/>
              <a:t>4/2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E1733-61A6-854D-A974-D957EC93B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299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99E19-0401-B847-99B3-5D6C4012EA79}" type="datetimeFigureOut">
              <a:rPr lang="en-US" smtClean="0"/>
              <a:t>4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E1733-61A6-854D-A974-D957EC93B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256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99E19-0401-B847-99B3-5D6C4012EA79}" type="datetimeFigureOut">
              <a:rPr lang="en-US" smtClean="0"/>
              <a:t>4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E1733-61A6-854D-A974-D957EC93B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5855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C99E19-0401-B847-99B3-5D6C4012EA79}" type="datetimeFigureOut">
              <a:rPr lang="en-US" smtClean="0"/>
              <a:t>4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E1733-61A6-854D-A974-D957EC93BF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891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945" y="128588"/>
            <a:ext cx="5917407" cy="7889875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266701" y="8166389"/>
            <a:ext cx="5995988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dirty="0">
                <a:latin typeface="Times New Roman" panose="02020603050405020304" pitchFamily="18" charset="0"/>
                <a:ea typeface="MS Mincho" panose="02020609040205080304" pitchFamily="49" charset="-128"/>
              </a:rPr>
              <a:t>Figure S1: Recurrent GBM tumors contain elevated tumor-derived vessels. (A) Brains containing tumors were removed and subjected to immunofluorescence (IF) analysis for CD105, a marker of intermediate endothelial cells and laminin, which indicates functional vessels. Tumors were identified via DAPI nuclear staining. (B) IF staining for </a:t>
            </a:r>
            <a:r>
              <a:rPr lang="en-US" sz="1000" dirty="0" err="1">
                <a:latin typeface="Times New Roman" panose="02020603050405020304" pitchFamily="18" charset="0"/>
                <a:ea typeface="MS Mincho" panose="02020609040205080304" pitchFamily="49" charset="-128"/>
              </a:rPr>
              <a:t>vWF</a:t>
            </a:r>
            <a:r>
              <a:rPr lang="en-US" sz="1000" dirty="0">
                <a:latin typeface="Times New Roman" panose="02020603050405020304" pitchFamily="18" charset="0"/>
                <a:ea typeface="MS Mincho" panose="02020609040205080304" pitchFamily="49" charset="-128"/>
              </a:rPr>
              <a:t>, a marker of mature blood vessels, and laminin. Images taken at 63x magnification. </a:t>
            </a:r>
          </a:p>
        </p:txBody>
      </p:sp>
    </p:spTree>
    <p:extLst>
      <p:ext uri="{BB962C8B-B14F-4D97-AF65-F5344CB8AC3E}">
        <p14:creationId xmlns:p14="http://schemas.microsoft.com/office/powerpoint/2010/main" val="145705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76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ck Shireman</dc:creator>
  <cp:lastModifiedBy>Jack Shireman</cp:lastModifiedBy>
  <cp:revision>1</cp:revision>
  <dcterms:created xsi:type="dcterms:W3CDTF">2019-04-21T16:24:59Z</dcterms:created>
  <dcterms:modified xsi:type="dcterms:W3CDTF">2019-04-21T16:26:00Z</dcterms:modified>
</cp:coreProperties>
</file>